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4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.png" ContentType="image/png"/>
  <Override PartName="/ppt/media/image24.png" ContentType="image/png"/>
  <Override PartName="/ppt/media/image25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31C06-B16E-4EEA-BCE6-40876749EB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8B1E8-AC41-4BF7-9574-3AC08A46D5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B4824-2379-4792-96D9-6567C2F716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6D738-9E0B-4CA1-87E0-8FEFCBD528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451D0-6617-4F7D-9C54-F5724858C8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886D6-6486-45D7-B65A-BAF63E3EAD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E6A1E-96B8-463F-9AC6-421A40BBBC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D48E5-487D-4A2C-9EF7-58FFC1DE09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A7625-A3C8-4BFC-8A64-970C0EEA6E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BB0B3-6C13-49F2-8871-C9E177B7E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A61C9-2341-4416-A066-DF5D80F383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B6AEE-5800-4633-96E0-3DB598ACE4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A193AD-82B3-4EBE-961E-12297B4E059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43"/>
          <p:cNvGrpSpPr/>
          <p:nvPr/>
        </p:nvGrpSpPr>
        <p:grpSpPr>
          <a:xfrm>
            <a:off x="1162080" y="2801880"/>
            <a:ext cx="1400040" cy="752400"/>
            <a:chOff x="1162080" y="2801880"/>
            <a:chExt cx="1400040" cy="752400"/>
          </a:xfrm>
        </p:grpSpPr>
        <p:pic>
          <p:nvPicPr>
            <p:cNvPr id="42" name="图片 41" descr=""/>
            <p:cNvPicPr/>
            <p:nvPr/>
          </p:nvPicPr>
          <p:blipFill>
            <a:blip r:embed="rId1"/>
            <a:stretch/>
          </p:blipFill>
          <p:spPr>
            <a:xfrm>
              <a:off x="1181160" y="2801880"/>
              <a:ext cx="1380960" cy="752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矩形 42"/>
            <p:cNvSpPr/>
            <p:nvPr/>
          </p:nvSpPr>
          <p:spPr>
            <a:xfrm>
              <a:off x="1162080" y="2843640"/>
              <a:ext cx="732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MM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组合 40"/>
          <p:cNvGrpSpPr/>
          <p:nvPr/>
        </p:nvGrpSpPr>
        <p:grpSpPr>
          <a:xfrm>
            <a:off x="6415200" y="2844720"/>
            <a:ext cx="1433520" cy="903240"/>
            <a:chOff x="6415200" y="2844720"/>
            <a:chExt cx="1433520" cy="903240"/>
          </a:xfrm>
        </p:grpSpPr>
        <p:pic>
          <p:nvPicPr>
            <p:cNvPr id="45" name="图片 4" descr=""/>
            <p:cNvPicPr/>
            <p:nvPr/>
          </p:nvPicPr>
          <p:blipFill>
            <a:blip r:embed="rId2"/>
            <a:stretch/>
          </p:blipFill>
          <p:spPr>
            <a:xfrm>
              <a:off x="6415200" y="2844720"/>
              <a:ext cx="1433520" cy="90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文本框 5"/>
            <p:cNvSpPr/>
            <p:nvPr/>
          </p:nvSpPr>
          <p:spPr>
            <a:xfrm>
              <a:off x="6415200" y="2844720"/>
              <a:ext cx="63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c-Ju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组合 46"/>
          <p:cNvGrpSpPr/>
          <p:nvPr/>
        </p:nvGrpSpPr>
        <p:grpSpPr>
          <a:xfrm>
            <a:off x="4530600" y="1554120"/>
            <a:ext cx="1650960" cy="847800"/>
            <a:chOff x="4530600" y="1554120"/>
            <a:chExt cx="1650960" cy="847800"/>
          </a:xfrm>
        </p:grpSpPr>
        <p:pic>
          <p:nvPicPr>
            <p:cNvPr id="48" name="图片 44" descr=""/>
            <p:cNvPicPr/>
            <p:nvPr/>
          </p:nvPicPr>
          <p:blipFill>
            <a:blip r:embed="rId3"/>
            <a:stretch/>
          </p:blipFill>
          <p:spPr>
            <a:xfrm>
              <a:off x="4530600" y="1554120"/>
              <a:ext cx="1650960" cy="847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文本框 45"/>
            <p:cNvSpPr/>
            <p:nvPr/>
          </p:nvSpPr>
          <p:spPr>
            <a:xfrm>
              <a:off x="4748400" y="1695960"/>
              <a:ext cx="74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MMP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组合 49"/>
          <p:cNvGrpSpPr/>
          <p:nvPr/>
        </p:nvGrpSpPr>
        <p:grpSpPr>
          <a:xfrm>
            <a:off x="2749680" y="2846520"/>
            <a:ext cx="1436400" cy="720720"/>
            <a:chOff x="2749680" y="2846520"/>
            <a:chExt cx="1436400" cy="720720"/>
          </a:xfrm>
        </p:grpSpPr>
        <p:pic>
          <p:nvPicPr>
            <p:cNvPr id="51" name="图片 47" descr=""/>
            <p:cNvPicPr/>
            <p:nvPr/>
          </p:nvPicPr>
          <p:blipFill>
            <a:blip r:embed="rId4"/>
            <a:stretch/>
          </p:blipFill>
          <p:spPr>
            <a:xfrm>
              <a:off x="2749680" y="2846520"/>
              <a:ext cx="1436400" cy="72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文本框 48"/>
            <p:cNvSpPr/>
            <p:nvPr/>
          </p:nvSpPr>
          <p:spPr>
            <a:xfrm>
              <a:off x="2851560" y="2892240"/>
              <a:ext cx="6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p-JN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组合 52"/>
          <p:cNvGrpSpPr/>
          <p:nvPr/>
        </p:nvGrpSpPr>
        <p:grpSpPr>
          <a:xfrm>
            <a:off x="6291360" y="1585800"/>
            <a:ext cx="1679400" cy="928800"/>
            <a:chOff x="6291360" y="1585800"/>
            <a:chExt cx="1679400" cy="928800"/>
          </a:xfrm>
        </p:grpSpPr>
        <p:pic>
          <p:nvPicPr>
            <p:cNvPr id="54" name="图片 50" descr=""/>
            <p:cNvPicPr/>
            <p:nvPr/>
          </p:nvPicPr>
          <p:blipFill>
            <a:blip r:embed="rId5"/>
            <a:stretch/>
          </p:blipFill>
          <p:spPr>
            <a:xfrm>
              <a:off x="6291360" y="1585800"/>
              <a:ext cx="1679400" cy="928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文本框 51"/>
            <p:cNvSpPr/>
            <p:nvPr/>
          </p:nvSpPr>
          <p:spPr>
            <a:xfrm>
              <a:off x="6546960" y="1719360"/>
              <a:ext cx="115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p-P38 MAP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1119240" y="4113360"/>
            <a:ext cx="1544760" cy="703080"/>
            <a:chOff x="1119240" y="4113360"/>
            <a:chExt cx="1544760" cy="703080"/>
          </a:xfrm>
        </p:grpSpPr>
        <p:pic>
          <p:nvPicPr>
            <p:cNvPr id="57" name="图片 53" descr=""/>
            <p:cNvPicPr/>
            <p:nvPr/>
          </p:nvPicPr>
          <p:blipFill>
            <a:blip r:embed="rId6"/>
            <a:stretch/>
          </p:blipFill>
          <p:spPr>
            <a:xfrm>
              <a:off x="1119240" y="4113360"/>
              <a:ext cx="1544760" cy="70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文本框 54"/>
            <p:cNvSpPr/>
            <p:nvPr/>
          </p:nvSpPr>
          <p:spPr>
            <a:xfrm>
              <a:off x="1344600" y="4170960"/>
              <a:ext cx="743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SIRT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4581360" y="2803680"/>
            <a:ext cx="1416240" cy="807840"/>
            <a:chOff x="4581360" y="2803680"/>
            <a:chExt cx="1416240" cy="807840"/>
          </a:xfrm>
        </p:grpSpPr>
        <p:pic>
          <p:nvPicPr>
            <p:cNvPr id="60" name="图片 56" descr=""/>
            <p:cNvPicPr/>
            <p:nvPr/>
          </p:nvPicPr>
          <p:blipFill>
            <a:blip r:embed="rId7"/>
            <a:stretch/>
          </p:blipFill>
          <p:spPr>
            <a:xfrm>
              <a:off x="4581360" y="2803680"/>
              <a:ext cx="1416240" cy="807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文本框 57"/>
            <p:cNvSpPr/>
            <p:nvPr/>
          </p:nvSpPr>
          <p:spPr>
            <a:xfrm>
              <a:off x="4584240" y="2803680"/>
              <a:ext cx="69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Smad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组合 64"/>
          <p:cNvGrpSpPr/>
          <p:nvPr/>
        </p:nvGrpSpPr>
        <p:grpSpPr>
          <a:xfrm>
            <a:off x="2717640" y="4172040"/>
            <a:ext cx="1500480" cy="691920"/>
            <a:chOff x="2717640" y="4172040"/>
            <a:chExt cx="1500480" cy="691920"/>
          </a:xfrm>
        </p:grpSpPr>
        <p:pic>
          <p:nvPicPr>
            <p:cNvPr id="63" name="图片 62" descr=""/>
            <p:cNvPicPr/>
            <p:nvPr/>
          </p:nvPicPr>
          <p:blipFill>
            <a:blip r:embed="rId8"/>
            <a:stretch/>
          </p:blipFill>
          <p:spPr>
            <a:xfrm>
              <a:off x="2717640" y="4172040"/>
              <a:ext cx="1500480" cy="691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文本框 63"/>
            <p:cNvSpPr/>
            <p:nvPr/>
          </p:nvSpPr>
          <p:spPr>
            <a:xfrm>
              <a:off x="2775600" y="4218120"/>
              <a:ext cx="7171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文本框 128"/>
          <p:cNvSpPr/>
          <p:nvPr/>
        </p:nvSpPr>
        <p:spPr>
          <a:xfrm>
            <a:off x="172440" y="947880"/>
            <a:ext cx="683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ig. 1H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1" descr=""/>
          <p:cNvPicPr/>
          <p:nvPr/>
        </p:nvPicPr>
        <p:blipFill>
          <a:blip r:embed="rId9"/>
          <a:stretch/>
        </p:blipFill>
        <p:spPr>
          <a:xfrm>
            <a:off x="1060560" y="1446120"/>
            <a:ext cx="1603440" cy="1208160"/>
          </a:xfrm>
          <a:prstGeom prst="rect">
            <a:avLst/>
          </a:prstGeom>
          <a:ln w="0">
            <a:noFill/>
          </a:ln>
        </p:spPr>
      </p:pic>
      <p:pic>
        <p:nvPicPr>
          <p:cNvPr id="67" name="图片 2" descr=""/>
          <p:cNvPicPr/>
          <p:nvPr/>
        </p:nvPicPr>
        <p:blipFill>
          <a:blip r:embed="rId10"/>
          <a:stretch/>
        </p:blipFill>
        <p:spPr>
          <a:xfrm>
            <a:off x="2813040" y="1486080"/>
            <a:ext cx="1539720" cy="882360"/>
          </a:xfrm>
          <a:prstGeom prst="rect">
            <a:avLst/>
          </a:prstGeom>
          <a:ln w="0">
            <a:noFill/>
          </a:ln>
        </p:spPr>
      </p:pic>
      <p:sp>
        <p:nvSpPr>
          <p:cNvPr id="68" name="文本框 99"/>
          <p:cNvSpPr/>
          <p:nvPr/>
        </p:nvSpPr>
        <p:spPr>
          <a:xfrm>
            <a:off x="955800" y="942840"/>
            <a:ext cx="3809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宋体"/>
              </a:rPr>
              <a:t>The raw images of the western blot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组合 34"/>
          <p:cNvGrpSpPr/>
          <p:nvPr/>
        </p:nvGrpSpPr>
        <p:grpSpPr>
          <a:xfrm>
            <a:off x="3054240" y="2701800"/>
            <a:ext cx="1652760" cy="852480"/>
            <a:chOff x="3054240" y="2701800"/>
            <a:chExt cx="1652760" cy="852480"/>
          </a:xfrm>
        </p:grpSpPr>
        <p:pic>
          <p:nvPicPr>
            <p:cNvPr id="70" name="图片 32" descr=""/>
            <p:cNvPicPr/>
            <p:nvPr/>
          </p:nvPicPr>
          <p:blipFill>
            <a:blip r:embed="rId1"/>
            <a:stretch/>
          </p:blipFill>
          <p:spPr>
            <a:xfrm>
              <a:off x="3054240" y="2701800"/>
              <a:ext cx="1652760" cy="852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文本框 33"/>
            <p:cNvSpPr/>
            <p:nvPr/>
          </p:nvSpPr>
          <p:spPr>
            <a:xfrm>
              <a:off x="3246480" y="2755800"/>
              <a:ext cx="63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c-Ju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组合 37"/>
          <p:cNvGrpSpPr/>
          <p:nvPr/>
        </p:nvGrpSpPr>
        <p:grpSpPr>
          <a:xfrm>
            <a:off x="1044720" y="1555920"/>
            <a:ext cx="1717560" cy="865080"/>
            <a:chOff x="1044720" y="1555920"/>
            <a:chExt cx="1717560" cy="865080"/>
          </a:xfrm>
        </p:grpSpPr>
        <p:pic>
          <p:nvPicPr>
            <p:cNvPr id="73" name="图片 35" descr=""/>
            <p:cNvPicPr/>
            <p:nvPr/>
          </p:nvPicPr>
          <p:blipFill>
            <a:blip r:embed="rId2"/>
            <a:stretch/>
          </p:blipFill>
          <p:spPr>
            <a:xfrm>
              <a:off x="1082160" y="1555920"/>
              <a:ext cx="1680120" cy="865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文本框 36"/>
            <p:cNvSpPr/>
            <p:nvPr/>
          </p:nvSpPr>
          <p:spPr>
            <a:xfrm>
              <a:off x="1044720" y="1639440"/>
              <a:ext cx="115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Collagen</a:t>
              </a:r>
              <a:r>
                <a:rPr b="0" lang="zh-CN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α</a:t>
              </a: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1(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组合 40"/>
          <p:cNvGrpSpPr/>
          <p:nvPr/>
        </p:nvGrpSpPr>
        <p:grpSpPr>
          <a:xfrm>
            <a:off x="1090440" y="2886120"/>
            <a:ext cx="1717920" cy="668160"/>
            <a:chOff x="1090440" y="2886120"/>
            <a:chExt cx="1717920" cy="668160"/>
          </a:xfrm>
        </p:grpSpPr>
        <p:pic>
          <p:nvPicPr>
            <p:cNvPr id="76" name="图片 38" descr=""/>
            <p:cNvPicPr/>
            <p:nvPr/>
          </p:nvPicPr>
          <p:blipFill>
            <a:blip r:embed="rId3"/>
            <a:stretch/>
          </p:blipFill>
          <p:spPr>
            <a:xfrm>
              <a:off x="1090440" y="2886120"/>
              <a:ext cx="1717920" cy="668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文本框 39"/>
            <p:cNvSpPr/>
            <p:nvPr/>
          </p:nvSpPr>
          <p:spPr>
            <a:xfrm>
              <a:off x="1152000" y="2894400"/>
              <a:ext cx="934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MM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组合 43"/>
          <p:cNvGrpSpPr/>
          <p:nvPr/>
        </p:nvGrpSpPr>
        <p:grpSpPr>
          <a:xfrm>
            <a:off x="4924440" y="1727280"/>
            <a:ext cx="1503360" cy="590400"/>
            <a:chOff x="4924440" y="1727280"/>
            <a:chExt cx="1503360" cy="590400"/>
          </a:xfrm>
        </p:grpSpPr>
        <p:pic>
          <p:nvPicPr>
            <p:cNvPr id="79" name="图片 41" descr=""/>
            <p:cNvPicPr/>
            <p:nvPr/>
          </p:nvPicPr>
          <p:blipFill>
            <a:blip r:embed="rId4"/>
            <a:stretch/>
          </p:blipFill>
          <p:spPr>
            <a:xfrm>
              <a:off x="4948560" y="1727280"/>
              <a:ext cx="1479240" cy="590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文本框 42"/>
            <p:cNvSpPr/>
            <p:nvPr/>
          </p:nvSpPr>
          <p:spPr>
            <a:xfrm>
              <a:off x="4924440" y="1775520"/>
              <a:ext cx="81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MMP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组合 46"/>
          <p:cNvGrpSpPr/>
          <p:nvPr/>
        </p:nvGrpSpPr>
        <p:grpSpPr>
          <a:xfrm>
            <a:off x="5013360" y="2766960"/>
            <a:ext cx="1498680" cy="692280"/>
            <a:chOff x="5013360" y="2766960"/>
            <a:chExt cx="1498680" cy="692280"/>
          </a:xfrm>
        </p:grpSpPr>
        <p:pic>
          <p:nvPicPr>
            <p:cNvPr id="82" name="图片 44" descr=""/>
            <p:cNvPicPr/>
            <p:nvPr/>
          </p:nvPicPr>
          <p:blipFill>
            <a:blip r:embed="rId5"/>
            <a:stretch/>
          </p:blipFill>
          <p:spPr>
            <a:xfrm>
              <a:off x="5013360" y="2766960"/>
              <a:ext cx="1498680" cy="69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文本框 45"/>
            <p:cNvSpPr/>
            <p:nvPr/>
          </p:nvSpPr>
          <p:spPr>
            <a:xfrm>
              <a:off x="5145120" y="28123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p-JN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组合 49"/>
          <p:cNvGrpSpPr/>
          <p:nvPr/>
        </p:nvGrpSpPr>
        <p:grpSpPr>
          <a:xfrm>
            <a:off x="6659640" y="1671480"/>
            <a:ext cx="1861920" cy="885960"/>
            <a:chOff x="6659640" y="1671480"/>
            <a:chExt cx="1861920" cy="885960"/>
          </a:xfrm>
        </p:grpSpPr>
        <p:pic>
          <p:nvPicPr>
            <p:cNvPr id="85" name="图片 47" descr=""/>
            <p:cNvPicPr/>
            <p:nvPr/>
          </p:nvPicPr>
          <p:blipFill>
            <a:blip r:embed="rId6"/>
            <a:stretch/>
          </p:blipFill>
          <p:spPr>
            <a:xfrm>
              <a:off x="6659640" y="1671480"/>
              <a:ext cx="1861920" cy="885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文本框 48"/>
            <p:cNvSpPr/>
            <p:nvPr/>
          </p:nvSpPr>
          <p:spPr>
            <a:xfrm>
              <a:off x="6897600" y="1769400"/>
              <a:ext cx="1155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p-P38 MAP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组合 52"/>
          <p:cNvGrpSpPr/>
          <p:nvPr/>
        </p:nvGrpSpPr>
        <p:grpSpPr>
          <a:xfrm>
            <a:off x="6834240" y="2766960"/>
            <a:ext cx="1687320" cy="793800"/>
            <a:chOff x="6834240" y="2766960"/>
            <a:chExt cx="1687320" cy="793800"/>
          </a:xfrm>
        </p:grpSpPr>
        <p:pic>
          <p:nvPicPr>
            <p:cNvPr id="88" name="图片 50" descr=""/>
            <p:cNvPicPr/>
            <p:nvPr/>
          </p:nvPicPr>
          <p:blipFill>
            <a:blip r:embed="rId7"/>
            <a:stretch/>
          </p:blipFill>
          <p:spPr>
            <a:xfrm>
              <a:off x="6834240" y="2766960"/>
              <a:ext cx="1687320" cy="793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文本框 51"/>
            <p:cNvSpPr/>
            <p:nvPr/>
          </p:nvSpPr>
          <p:spPr>
            <a:xfrm>
              <a:off x="7041600" y="2848680"/>
              <a:ext cx="70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SIRT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组合 55"/>
          <p:cNvGrpSpPr/>
          <p:nvPr/>
        </p:nvGrpSpPr>
        <p:grpSpPr>
          <a:xfrm>
            <a:off x="1044720" y="4067280"/>
            <a:ext cx="1528560" cy="739800"/>
            <a:chOff x="1044720" y="4067280"/>
            <a:chExt cx="1528560" cy="739800"/>
          </a:xfrm>
        </p:grpSpPr>
        <p:pic>
          <p:nvPicPr>
            <p:cNvPr id="91" name="图片 53" descr=""/>
            <p:cNvPicPr/>
            <p:nvPr/>
          </p:nvPicPr>
          <p:blipFill>
            <a:blip r:embed="rId8"/>
            <a:stretch/>
          </p:blipFill>
          <p:spPr>
            <a:xfrm>
              <a:off x="1044720" y="4129560"/>
              <a:ext cx="1528560" cy="677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文本框 54"/>
            <p:cNvSpPr/>
            <p:nvPr/>
          </p:nvSpPr>
          <p:spPr>
            <a:xfrm>
              <a:off x="1075680" y="4067280"/>
              <a:ext cx="81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Smad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组合 58"/>
          <p:cNvGrpSpPr/>
          <p:nvPr/>
        </p:nvGrpSpPr>
        <p:grpSpPr>
          <a:xfrm>
            <a:off x="2959200" y="1589040"/>
            <a:ext cx="1601640" cy="754200"/>
            <a:chOff x="2959200" y="1589040"/>
            <a:chExt cx="1601640" cy="754200"/>
          </a:xfrm>
        </p:grpSpPr>
        <p:pic>
          <p:nvPicPr>
            <p:cNvPr id="94" name="图片 56" descr=""/>
            <p:cNvPicPr/>
            <p:nvPr/>
          </p:nvPicPr>
          <p:blipFill>
            <a:blip r:embed="rId9"/>
            <a:stretch/>
          </p:blipFill>
          <p:spPr>
            <a:xfrm>
              <a:off x="2959200" y="1589040"/>
              <a:ext cx="1601640" cy="75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文本框 57"/>
            <p:cNvSpPr/>
            <p:nvPr/>
          </p:nvSpPr>
          <p:spPr>
            <a:xfrm>
              <a:off x="3263760" y="1681200"/>
              <a:ext cx="73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TGF-</a:t>
              </a:r>
              <a:r>
                <a:rPr b="0" lang="zh-CN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β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组合 61"/>
          <p:cNvGrpSpPr/>
          <p:nvPr/>
        </p:nvGrpSpPr>
        <p:grpSpPr>
          <a:xfrm>
            <a:off x="3030480" y="4129200"/>
            <a:ext cx="1790640" cy="836640"/>
            <a:chOff x="3030480" y="4129200"/>
            <a:chExt cx="1790640" cy="836640"/>
          </a:xfrm>
        </p:grpSpPr>
        <p:pic>
          <p:nvPicPr>
            <p:cNvPr id="97" name="图片 59" descr=""/>
            <p:cNvPicPr/>
            <p:nvPr/>
          </p:nvPicPr>
          <p:blipFill>
            <a:blip r:embed="rId10"/>
            <a:stretch/>
          </p:blipFill>
          <p:spPr>
            <a:xfrm>
              <a:off x="3030480" y="4129200"/>
              <a:ext cx="1790640" cy="836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文本框 60"/>
            <p:cNvSpPr/>
            <p:nvPr/>
          </p:nvSpPr>
          <p:spPr>
            <a:xfrm>
              <a:off x="3046680" y="4220280"/>
              <a:ext cx="85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Tubul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文本框 88"/>
          <p:cNvSpPr/>
          <p:nvPr/>
        </p:nvSpPr>
        <p:spPr>
          <a:xfrm>
            <a:off x="74160" y="898560"/>
            <a:ext cx="683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ig. 2G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本框 99"/>
          <p:cNvSpPr/>
          <p:nvPr/>
        </p:nvSpPr>
        <p:spPr>
          <a:xfrm>
            <a:off x="808200" y="903240"/>
            <a:ext cx="3809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宋体"/>
              </a:rPr>
              <a:t>The raw images of the western blot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组合 28"/>
          <p:cNvGrpSpPr/>
          <p:nvPr/>
        </p:nvGrpSpPr>
        <p:grpSpPr>
          <a:xfrm>
            <a:off x="739800" y="2693880"/>
            <a:ext cx="1238400" cy="868320"/>
            <a:chOff x="739800" y="2693880"/>
            <a:chExt cx="1238400" cy="868320"/>
          </a:xfrm>
        </p:grpSpPr>
        <p:pic>
          <p:nvPicPr>
            <p:cNvPr id="102" name="图片 26" descr=""/>
            <p:cNvPicPr/>
            <p:nvPr/>
          </p:nvPicPr>
          <p:blipFill>
            <a:blip r:embed="rId1"/>
            <a:stretch/>
          </p:blipFill>
          <p:spPr>
            <a:xfrm>
              <a:off x="739800" y="2693880"/>
              <a:ext cx="1238400" cy="868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文本框 27"/>
            <p:cNvSpPr/>
            <p:nvPr/>
          </p:nvSpPr>
          <p:spPr>
            <a:xfrm>
              <a:off x="814680" y="2720880"/>
              <a:ext cx="645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c-Ju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组合 31"/>
          <p:cNvGrpSpPr/>
          <p:nvPr/>
        </p:nvGrpSpPr>
        <p:grpSpPr>
          <a:xfrm>
            <a:off x="658800" y="1635120"/>
            <a:ext cx="1374840" cy="665280"/>
            <a:chOff x="658800" y="1635120"/>
            <a:chExt cx="1374840" cy="665280"/>
          </a:xfrm>
        </p:grpSpPr>
        <p:pic>
          <p:nvPicPr>
            <p:cNvPr id="105" name="图片 29" descr=""/>
            <p:cNvPicPr/>
            <p:nvPr/>
          </p:nvPicPr>
          <p:blipFill>
            <a:blip r:embed="rId2"/>
            <a:stretch/>
          </p:blipFill>
          <p:spPr>
            <a:xfrm>
              <a:off x="658800" y="1635120"/>
              <a:ext cx="1374840" cy="66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文本框 30"/>
            <p:cNvSpPr/>
            <p:nvPr/>
          </p:nvSpPr>
          <p:spPr>
            <a:xfrm>
              <a:off x="897840" y="1654560"/>
              <a:ext cx="105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Collagen</a:t>
              </a:r>
              <a:r>
                <a:rPr b="0" lang="zh-CN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α</a:t>
              </a:r>
              <a:r>
                <a:rPr b="0" lang="en-US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1(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组合 34"/>
          <p:cNvGrpSpPr/>
          <p:nvPr/>
        </p:nvGrpSpPr>
        <p:grpSpPr>
          <a:xfrm>
            <a:off x="2038320" y="1631880"/>
            <a:ext cx="1373040" cy="822240"/>
            <a:chOff x="2038320" y="1631880"/>
            <a:chExt cx="1373040" cy="822240"/>
          </a:xfrm>
        </p:grpSpPr>
        <p:pic>
          <p:nvPicPr>
            <p:cNvPr id="108" name="图片 32" descr=""/>
            <p:cNvPicPr/>
            <p:nvPr/>
          </p:nvPicPr>
          <p:blipFill>
            <a:blip r:embed="rId3"/>
            <a:stretch/>
          </p:blipFill>
          <p:spPr>
            <a:xfrm>
              <a:off x="2038320" y="1631880"/>
              <a:ext cx="1373040" cy="82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文本框 33"/>
            <p:cNvSpPr/>
            <p:nvPr/>
          </p:nvSpPr>
          <p:spPr>
            <a:xfrm>
              <a:off x="2187000" y="1763640"/>
              <a:ext cx="62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MMP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0" name="组合 37"/>
          <p:cNvGrpSpPr/>
          <p:nvPr/>
        </p:nvGrpSpPr>
        <p:grpSpPr>
          <a:xfrm>
            <a:off x="3632040" y="1655640"/>
            <a:ext cx="1181160" cy="803520"/>
            <a:chOff x="3632040" y="1655640"/>
            <a:chExt cx="1181160" cy="803520"/>
          </a:xfrm>
        </p:grpSpPr>
        <p:pic>
          <p:nvPicPr>
            <p:cNvPr id="111" name="图片 35" descr=""/>
            <p:cNvPicPr/>
            <p:nvPr/>
          </p:nvPicPr>
          <p:blipFill>
            <a:blip r:embed="rId4"/>
            <a:stretch/>
          </p:blipFill>
          <p:spPr>
            <a:xfrm>
              <a:off x="3636720" y="1655640"/>
              <a:ext cx="1176480" cy="80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文本框 36"/>
            <p:cNvSpPr/>
            <p:nvPr/>
          </p:nvSpPr>
          <p:spPr>
            <a:xfrm>
              <a:off x="3632040" y="1779120"/>
              <a:ext cx="742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微软雅黑"/>
                  <a:ea typeface="微软雅黑"/>
                </a:rPr>
                <a:t>Smad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13" name="图片 38" descr=""/>
          <p:cNvPicPr/>
          <p:nvPr/>
        </p:nvPicPr>
        <p:blipFill>
          <a:blip r:embed="rId5"/>
          <a:stretch/>
        </p:blipFill>
        <p:spPr>
          <a:xfrm>
            <a:off x="2038320" y="2846520"/>
            <a:ext cx="1554120" cy="688680"/>
          </a:xfrm>
          <a:prstGeom prst="rect">
            <a:avLst/>
          </a:prstGeom>
          <a:ln w="0">
            <a:noFill/>
          </a:ln>
        </p:spPr>
      </p:pic>
      <p:sp>
        <p:nvSpPr>
          <p:cNvPr id="114" name="文本框 39"/>
          <p:cNvSpPr/>
          <p:nvPr/>
        </p:nvSpPr>
        <p:spPr>
          <a:xfrm>
            <a:off x="2232000" y="2894040"/>
            <a:ext cx="59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微软雅黑"/>
                <a:ea typeface="微软雅黑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69"/>
          <p:cNvSpPr/>
          <p:nvPr/>
        </p:nvSpPr>
        <p:spPr>
          <a:xfrm>
            <a:off x="72720" y="898560"/>
            <a:ext cx="6289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ig. 2J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文本框 1"/>
          <p:cNvSpPr/>
          <p:nvPr/>
        </p:nvSpPr>
        <p:spPr>
          <a:xfrm>
            <a:off x="689040" y="907920"/>
            <a:ext cx="3809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宋体"/>
              </a:rPr>
              <a:t>The raw images of the western blot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5-07T06:22:54Z</dcterms:created>
  <dc:creator>涂鸦——</dc:creator>
  <dc:description/>
  <dc:language>en-US</dc:language>
  <cp:lastModifiedBy>涂鸦——</cp:lastModifiedBy>
  <dcterms:modified xsi:type="dcterms:W3CDTF">2022-05-07T06:22:54Z</dcterms:modified>
  <cp:revision>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559</vt:lpwstr>
  </property>
</Properties>
</file>